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7" r:id="rId2"/>
    <p:sldId id="278" r:id="rId3"/>
    <p:sldId id="280" r:id="rId4"/>
  </p:sldIdLst>
  <p:sldSz cx="11339513" cy="16038513"/>
  <p:notesSz cx="6797675" cy="9926638"/>
  <p:defaultTextStyle>
    <a:defPPr>
      <a:defRPr lang="en-US"/>
    </a:defPPr>
    <a:lvl1pPr marL="0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1pPr>
    <a:lvl2pPr marL="746588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2pPr>
    <a:lvl3pPr marL="1493178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3pPr>
    <a:lvl4pPr marL="2239766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4pPr>
    <a:lvl5pPr marL="2986354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5pPr>
    <a:lvl6pPr marL="3732944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6pPr>
    <a:lvl7pPr marL="4479532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7pPr>
    <a:lvl8pPr marL="5226121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8pPr>
    <a:lvl9pPr marL="5972710" algn="l" defTabSz="1493178" rtl="0" eaLnBrk="1" latinLnBrk="0" hangingPunct="1">
      <a:defRPr sz="293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75" userDrawn="1">
          <p15:clr>
            <a:srgbClr val="A4A3A4"/>
          </p15:clr>
        </p15:guide>
        <p15:guide id="3" orient="horz" pos="53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0000FF"/>
    <a:srgbClr val="00CC00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Style moyen 3 - Accentuation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60"/>
  </p:normalViewPr>
  <p:slideViewPr>
    <p:cSldViewPr>
      <p:cViewPr>
        <p:scale>
          <a:sx n="60" d="100"/>
          <a:sy n="60" d="100"/>
        </p:scale>
        <p:origin x="976" y="-1268"/>
      </p:cViewPr>
      <p:guideLst>
        <p:guide pos="2075"/>
        <p:guide orient="horz" pos="53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0A44DE-E19F-4B03-9BDD-41D0CBB62CA4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82800" y="744538"/>
            <a:ext cx="26320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9B9E6B-4EB4-4966-BCBC-C064A45C8D7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05397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746588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1493178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2239766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2986354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3732944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4479532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5226121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5972710" algn="l" defTabSz="1493178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0464" y="4982339"/>
            <a:ext cx="9638586" cy="343788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00927" y="9088491"/>
            <a:ext cx="7937659" cy="409873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7856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667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906242" y="642288"/>
            <a:ext cx="2764007" cy="1368471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4225" y="642288"/>
            <a:ext cx="8103028" cy="1368471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3384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763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5744" y="10306233"/>
            <a:ext cx="9638586" cy="318542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5744" y="6797809"/>
            <a:ext cx="9638586" cy="350842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602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4225" y="3742323"/>
            <a:ext cx="5433517" cy="105846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36734" y="3742323"/>
            <a:ext cx="5433517" cy="1058467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3861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976" y="642283"/>
            <a:ext cx="10205562" cy="267308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977" y="3590104"/>
            <a:ext cx="5010254" cy="14961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977" y="5086287"/>
            <a:ext cx="5010254" cy="924071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60316" y="3590104"/>
            <a:ext cx="5012224" cy="14961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60316" y="5086287"/>
            <a:ext cx="5012224" cy="924071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5766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661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7087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977" y="638570"/>
            <a:ext cx="3730622" cy="27176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3436" y="638575"/>
            <a:ext cx="6339102" cy="136884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977" y="3356211"/>
            <a:ext cx="3730622" cy="1097079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514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22623" y="11226959"/>
            <a:ext cx="6803708" cy="132540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222623" y="1433070"/>
            <a:ext cx="6803708" cy="962310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22623" y="12552367"/>
            <a:ext cx="6803708" cy="188229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346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6976" y="642283"/>
            <a:ext cx="10205562" cy="26730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976" y="3742323"/>
            <a:ext cx="10205562" cy="105846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6976" y="14865331"/>
            <a:ext cx="2645886" cy="853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A3947-DC04-4968-A26A-A319DDA02269}" type="datetimeFigureOut">
              <a:rPr lang="en-GB" smtClean="0"/>
              <a:t>13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74334" y="14865331"/>
            <a:ext cx="3590846" cy="853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26651" y="14865331"/>
            <a:ext cx="2645886" cy="853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99E7F-E2E3-4043-A0E7-457040DB826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2272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8.emf"/><Relationship Id="rId18" Type="http://schemas.openxmlformats.org/officeDocument/2006/relationships/image" Target="../media/image5.emf"/><Relationship Id="rId3" Type="http://schemas.openxmlformats.org/officeDocument/2006/relationships/image" Target="../media/image6.emf"/><Relationship Id="rId7" Type="http://schemas.openxmlformats.org/officeDocument/2006/relationships/image" Target="../media/image2.emf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10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emf"/><Relationship Id="rId3" Type="http://schemas.openxmlformats.org/officeDocument/2006/relationships/image" Target="../media/image13.png"/><Relationship Id="rId7" Type="http://schemas.openxmlformats.org/officeDocument/2006/relationships/image" Target="../media/image16.png"/><Relationship Id="rId12" Type="http://schemas.openxmlformats.org/officeDocument/2006/relationships/image" Target="../media/image21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microsoft.com/office/2007/relationships/hdphoto" Target="../media/hdphoto1.wdp"/><Relationship Id="rId9" Type="http://schemas.openxmlformats.org/officeDocument/2006/relationships/image" Target="../media/image18.png"/><Relationship Id="rId1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999737"/>
              </p:ext>
            </p:extLst>
          </p:nvPr>
        </p:nvGraphicFramePr>
        <p:xfrm>
          <a:off x="1421285" y="3065845"/>
          <a:ext cx="8819999" cy="3240361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447412">
                  <a:extLst>
                    <a:ext uri="{9D8B030D-6E8A-4147-A177-3AD203B41FA5}">
                      <a16:colId xmlns:a16="http://schemas.microsoft.com/office/drawing/2014/main" val="2606139740"/>
                    </a:ext>
                  </a:extLst>
                </a:gridCol>
                <a:gridCol w="1606434">
                  <a:extLst>
                    <a:ext uri="{9D8B030D-6E8A-4147-A177-3AD203B41FA5}">
                      <a16:colId xmlns:a16="http://schemas.microsoft.com/office/drawing/2014/main" val="12343983"/>
                    </a:ext>
                  </a:extLst>
                </a:gridCol>
                <a:gridCol w="1607363">
                  <a:extLst>
                    <a:ext uri="{9D8B030D-6E8A-4147-A177-3AD203B41FA5}">
                      <a16:colId xmlns:a16="http://schemas.microsoft.com/office/drawing/2014/main" val="919474335"/>
                    </a:ext>
                  </a:extLst>
                </a:gridCol>
                <a:gridCol w="1607363">
                  <a:extLst>
                    <a:ext uri="{9D8B030D-6E8A-4147-A177-3AD203B41FA5}">
                      <a16:colId xmlns:a16="http://schemas.microsoft.com/office/drawing/2014/main" val="2798893629"/>
                    </a:ext>
                  </a:extLst>
                </a:gridCol>
                <a:gridCol w="1551427">
                  <a:extLst>
                    <a:ext uri="{9D8B030D-6E8A-4147-A177-3AD203B41FA5}">
                      <a16:colId xmlns:a16="http://schemas.microsoft.com/office/drawing/2014/main" val="663483981"/>
                    </a:ext>
                  </a:extLst>
                </a:gridCol>
              </a:tblGrid>
              <a:tr h="72442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- Megakaryocyte </a:t>
                      </a:r>
                    </a:p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</a:t>
                      </a: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oproteins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CAM-1 KO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IR-1 KO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KO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9924047"/>
                  </a:ext>
                </a:extLst>
              </a:tr>
              <a:tr h="35622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VI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8±3.7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±6.0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2±3.6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±3.8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4521263"/>
                  </a:ext>
                </a:extLst>
              </a:tr>
              <a:tr h="367406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in α2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8±5.6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3±7.5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9±5.5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6±5.0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0771873"/>
                  </a:ext>
                </a:extLst>
              </a:tr>
              <a:tr h="35622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Ibα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9±22.4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7±28.4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2±22.0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8±31.8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5470875"/>
                  </a:ext>
                </a:extLst>
              </a:tr>
              <a:tr h="367406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in αIIbβ3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.5±37.8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.9±39.6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.6±28.3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.1±37.0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9031710"/>
                  </a:ext>
                </a:extLst>
              </a:tr>
              <a:tr h="35622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-2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.8±16.8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.1±18.2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0±15.5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.1±16.3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7847200"/>
                  </a:ext>
                </a:extLst>
              </a:tr>
              <a:tr h="35622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fr-FR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B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5±11.6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7±6.1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3±9.4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2±7.6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0090385"/>
                  </a:ext>
                </a:extLst>
              </a:tr>
              <a:tr h="35622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CAM-1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3±11.1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.2±6.5 **</a:t>
                      </a:r>
                      <a:endParaRPr lang="fr-FR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8±13.2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7±10.1 **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2994402"/>
                  </a:ext>
                </a:extLst>
              </a:tr>
            </a:tbl>
          </a:graphicData>
        </a:graphic>
      </p:graphicFrame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1421284" y="1712154"/>
            <a:ext cx="8820000" cy="1046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Tables</a:t>
            </a:r>
            <a:r>
              <a:rPr kumimoji="0" lang="en-GB" altLang="fr-FR" sz="16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1-S2</a:t>
            </a:r>
            <a:r>
              <a:rPr kumimoji="0" lang="en-GB" altLang="fr-FR" sz="1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Megakaryocyte and platelet surface glycoproteins expression in LAIR-1/PECAM-1 double KO mice. </a:t>
            </a:r>
            <a:endParaRPr kumimoji="0" lang="en-GB" altLang="fr-FR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fr-FR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ta represents mean values of </a:t>
            </a:r>
            <a:r>
              <a:rPr kumimoji="0" lang="en-GB" altLang="fr-FR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geometric mean fluorescence intensity ± SEM; n = 4-10 for platelets, n = 4-5 for megakaryocytes,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 &lt; .01, ***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 &lt; .001, 1-way ANOVA with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ida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endParaRPr kumimoji="0" lang="en-GB" altLang="fr-F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1166163"/>
              </p:ext>
            </p:extLst>
          </p:nvPr>
        </p:nvGraphicFramePr>
        <p:xfrm>
          <a:off x="1421284" y="6594237"/>
          <a:ext cx="8820000" cy="3239997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2447404">
                  <a:extLst>
                    <a:ext uri="{9D8B030D-6E8A-4147-A177-3AD203B41FA5}">
                      <a16:colId xmlns:a16="http://schemas.microsoft.com/office/drawing/2014/main" val="1509521455"/>
                    </a:ext>
                  </a:extLst>
                </a:gridCol>
                <a:gridCol w="1606435">
                  <a:extLst>
                    <a:ext uri="{9D8B030D-6E8A-4147-A177-3AD203B41FA5}">
                      <a16:colId xmlns:a16="http://schemas.microsoft.com/office/drawing/2014/main" val="1456782641"/>
                    </a:ext>
                  </a:extLst>
                </a:gridCol>
                <a:gridCol w="1607370">
                  <a:extLst>
                    <a:ext uri="{9D8B030D-6E8A-4147-A177-3AD203B41FA5}">
                      <a16:colId xmlns:a16="http://schemas.microsoft.com/office/drawing/2014/main" val="1616010076"/>
                    </a:ext>
                  </a:extLst>
                </a:gridCol>
                <a:gridCol w="1607370">
                  <a:extLst>
                    <a:ext uri="{9D8B030D-6E8A-4147-A177-3AD203B41FA5}">
                      <a16:colId xmlns:a16="http://schemas.microsoft.com/office/drawing/2014/main" val="1597083362"/>
                    </a:ext>
                  </a:extLst>
                </a:gridCol>
                <a:gridCol w="1551421">
                  <a:extLst>
                    <a:ext uri="{9D8B030D-6E8A-4147-A177-3AD203B41FA5}">
                      <a16:colId xmlns:a16="http://schemas.microsoft.com/office/drawing/2014/main" val="1654132186"/>
                    </a:ext>
                  </a:extLst>
                </a:gridCol>
              </a:tblGrid>
              <a:tr h="710134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- Platelet </a:t>
                      </a:r>
                    </a:p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</a:t>
                      </a: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oproteins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CAM-1 KO</a:t>
                      </a:r>
                      <a:endParaRPr lang="fr-FR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IR-1 KO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KO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5856661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VI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22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49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0±158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17±1252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i-FI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7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55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6545938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in α2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8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6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0±22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9±16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7±6 *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9174486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Ib</a:t>
                      </a: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15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384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i-FI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98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406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fi-FI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02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349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90±245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7268665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in α</a:t>
                      </a:r>
                      <a:r>
                        <a:rPr lang="en-US" sz="1400" kern="12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b</a:t>
                      </a: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3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86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997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12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171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80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130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85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102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07837742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-2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3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541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33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17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94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266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43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55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5529159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fr-FR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B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2±128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nb-NO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9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28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nb-NO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5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21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s-I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5</a:t>
                      </a: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02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1263451"/>
                  </a:ext>
                </a:extLst>
              </a:tr>
              <a:tr h="361409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CAM-1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</a:t>
                      </a: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57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±23 ***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4±34</a:t>
                      </a:r>
                      <a:endParaRPr lang="fr-F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±19 ***</a:t>
                      </a:r>
                      <a:endParaRPr lang="fr-FR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2700" marR="12700" marT="1270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5772889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83291" y="421607"/>
            <a:ext cx="1587034" cy="36933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GB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ith et al</a:t>
            </a:r>
            <a:endParaRPr lang="en-GB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4633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1733" y="1885330"/>
            <a:ext cx="3956050" cy="274955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83291" y="421607"/>
            <a:ext cx="1587034" cy="36933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GB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ith et al</a:t>
            </a:r>
            <a:endParaRPr lang="en-GB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439549" y="782743"/>
            <a:ext cx="88200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1:</a:t>
            </a:r>
            <a:r>
              <a:rPr kumimoji="0" lang="en-GB" altLang="fr-FR" sz="1400" b="1" i="0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latelet clearance in DKO mice.</a:t>
            </a:r>
            <a:r>
              <a:rPr kumimoji="0" lang="en-GB" altLang="fr-FR" sz="1400" b="1" i="0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latele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alf-life was measured b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ow cytometr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fter quantification of the number of biotin+α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I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β3+ platelets in the circulation of litter-matched WT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KO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c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ily </a:t>
            </a:r>
            <a:r>
              <a:rPr lang="fr-F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post-injection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bioti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ydroxysuccinimid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± SEM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= 4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fr-F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FR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otype</a:t>
            </a:r>
            <a:r>
              <a:rPr lang="fr-F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/time point.</a:t>
            </a:r>
            <a:endParaRPr kumimoji="0" lang="en-GB" altLang="fr-F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/>
          <p:cNvSpPr>
            <a:spLocks noChangeArrowheads="1"/>
          </p:cNvSpPr>
          <p:nvPr/>
        </p:nvSpPr>
        <p:spPr bwMode="auto">
          <a:xfrm>
            <a:off x="1267598" y="5003412"/>
            <a:ext cx="8820000" cy="1169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fr-FR" sz="14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</a:t>
            </a:r>
            <a:r>
              <a:rPr kumimoji="0" lang="en-GB" altLang="fr-FR" sz="14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:</a:t>
            </a:r>
            <a:r>
              <a:rPr kumimoji="0" lang="en-GB" altLang="fr-FR" sz="1400" b="1" i="0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AIR-1/PECAM-1 DKO mouse platelets exhibit increase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PVI-induced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latelet aggregation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ashed platelets from PECAM-1 KO, LAIR-1 KO, LAIR-1/PECAM-1 DKO and litter-matched WT mice were stimulated with 0.3, 1 or 3 µg/mL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llagen-related peptide (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RP).  Percentag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f platelet aggregation and ATP secretion (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were measured using 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lumi-aggregomet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 Average traces and area under the curve (AUC) quantification from 4-17 mice/genotype are represente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*P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&lt;0.05,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**P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1.</a:t>
            </a:r>
            <a:endParaRPr kumimoji="0" lang="en-GB" altLang="fr-F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4" name="Objet 9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7499142"/>
              </p:ext>
            </p:extLst>
          </p:nvPr>
        </p:nvGraphicFramePr>
        <p:xfrm>
          <a:off x="6096042" y="6760204"/>
          <a:ext cx="2212975" cy="2779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9" r:id="rId4" imgW="2604141" imgH="3269588" progId="Prism9.Document">
                  <p:embed/>
                </p:oleObj>
              </mc:Choice>
              <mc:Fallback>
                <p:oleObj name="Prism 9" r:id="rId4" imgW="2604141" imgH="3269588" progId="Prism9.Document">
                  <p:embed/>
                  <p:pic>
                    <p:nvPicPr>
                      <p:cNvPr id="3" name="Obje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6042" y="6760204"/>
                        <a:ext cx="2212975" cy="2779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5" name="Objet 9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5298831"/>
              </p:ext>
            </p:extLst>
          </p:nvPr>
        </p:nvGraphicFramePr>
        <p:xfrm>
          <a:off x="2714571" y="9507741"/>
          <a:ext cx="2212975" cy="32263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name="Prism 9" r:id="rId6" imgW="2604141" imgH="3795257" progId="Prism9.Document">
                  <p:embed/>
                </p:oleObj>
              </mc:Choice>
              <mc:Fallback>
                <p:oleObj name="Prism 9" r:id="rId6" imgW="2604141" imgH="3795257" progId="Prism9.Document">
                  <p:embed/>
                  <p:pic>
                    <p:nvPicPr>
                      <p:cNvPr id="4" name="Objet 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14571" y="9507741"/>
                        <a:ext cx="2212975" cy="32263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6" name="Objet 9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9809590"/>
              </p:ext>
            </p:extLst>
          </p:nvPr>
        </p:nvGraphicFramePr>
        <p:xfrm>
          <a:off x="8666157" y="9844056"/>
          <a:ext cx="2212975" cy="29011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name="Prism 9" r:id="rId8" imgW="2604141" imgH="3412527" progId="Prism9.Document">
                  <p:embed/>
                </p:oleObj>
              </mc:Choice>
              <mc:Fallback>
                <p:oleObj name="Prism 9" r:id="rId8" imgW="2604141" imgH="3412527" progId="Prism9.Document">
                  <p:embed/>
                  <p:pic>
                    <p:nvPicPr>
                      <p:cNvPr id="5" name="Objet 4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666157" y="9844056"/>
                        <a:ext cx="2212975" cy="29011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7" name="Objet 9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0929515"/>
              </p:ext>
            </p:extLst>
          </p:nvPr>
        </p:nvGraphicFramePr>
        <p:xfrm>
          <a:off x="8806442" y="12377048"/>
          <a:ext cx="2086134" cy="30590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2" name="Prism 9" r:id="rId10" imgW="2454685" imgH="3598671" progId="Prism9.Document">
                  <p:embed/>
                </p:oleObj>
              </mc:Choice>
              <mc:Fallback>
                <p:oleObj name="Prism 9" r:id="rId10" imgW="2454685" imgH="3598671" progId="Prism9.Document">
                  <p:embed/>
                  <p:pic>
                    <p:nvPicPr>
                      <p:cNvPr id="7" name="Objet 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806442" y="12377048"/>
                        <a:ext cx="2086134" cy="30590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8" name="Groupe 97"/>
          <p:cNvGrpSpPr/>
          <p:nvPr/>
        </p:nvGrpSpPr>
        <p:grpSpPr>
          <a:xfrm>
            <a:off x="2031486" y="7268641"/>
            <a:ext cx="1343616" cy="1146009"/>
            <a:chOff x="9401340" y="1876425"/>
            <a:chExt cx="1580725" cy="1348246"/>
          </a:xfrm>
        </p:grpSpPr>
        <p:grpSp>
          <p:nvGrpSpPr>
            <p:cNvPr id="99" name="Group 2"/>
            <p:cNvGrpSpPr/>
            <p:nvPr/>
          </p:nvGrpSpPr>
          <p:grpSpPr>
            <a:xfrm>
              <a:off x="9401340" y="1876425"/>
              <a:ext cx="740766" cy="307777"/>
              <a:chOff x="889772" y="3632795"/>
              <a:chExt cx="575716" cy="224823"/>
            </a:xfrm>
          </p:grpSpPr>
          <p:cxnSp>
            <p:nvCxnSpPr>
              <p:cNvPr id="109" name="Straight Connector 4"/>
              <p:cNvCxnSpPr/>
              <p:nvPr/>
            </p:nvCxnSpPr>
            <p:spPr>
              <a:xfrm>
                <a:off x="889772" y="3786683"/>
                <a:ext cx="180000" cy="0"/>
              </a:xfrm>
              <a:prstGeom prst="line">
                <a:avLst/>
              </a:prstGeom>
              <a:ln w="571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4"/>
              <p:cNvSpPr txBox="1"/>
              <p:nvPr/>
            </p:nvSpPr>
            <p:spPr>
              <a:xfrm>
                <a:off x="1105192" y="3632795"/>
                <a:ext cx="360296" cy="224823"/>
              </a:xfrm>
              <a:prstGeom prst="rect">
                <a:avLst/>
              </a:prstGeom>
              <a:noFill/>
              <a:ln w="571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grpSp>
          <p:nvGrpSpPr>
            <p:cNvPr id="100" name="Group 5"/>
            <p:cNvGrpSpPr/>
            <p:nvPr/>
          </p:nvGrpSpPr>
          <p:grpSpPr>
            <a:xfrm>
              <a:off x="9401340" y="2196813"/>
              <a:ext cx="1580725" cy="307777"/>
              <a:chOff x="889772" y="3831478"/>
              <a:chExt cx="1228525" cy="224823"/>
            </a:xfrm>
          </p:grpSpPr>
          <p:cxnSp>
            <p:nvCxnSpPr>
              <p:cNvPr id="107" name="Straight Connector 118"/>
              <p:cNvCxnSpPr/>
              <p:nvPr/>
            </p:nvCxnSpPr>
            <p:spPr>
              <a:xfrm>
                <a:off x="889772" y="3985366"/>
                <a:ext cx="180000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21"/>
              <p:cNvSpPr txBox="1"/>
              <p:nvPr/>
            </p:nvSpPr>
            <p:spPr>
              <a:xfrm>
                <a:off x="1098951" y="3831478"/>
                <a:ext cx="1019346" cy="224823"/>
              </a:xfrm>
              <a:prstGeom prst="rect">
                <a:avLst/>
              </a:prstGeom>
              <a:noFill/>
              <a:ln w="571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CAM-1 KO</a:t>
                </a:r>
              </a:p>
            </p:txBody>
          </p:sp>
        </p:grpSp>
        <p:grpSp>
          <p:nvGrpSpPr>
            <p:cNvPr id="101" name="Group 15"/>
            <p:cNvGrpSpPr/>
            <p:nvPr/>
          </p:nvGrpSpPr>
          <p:grpSpPr>
            <a:xfrm>
              <a:off x="9401340" y="2556854"/>
              <a:ext cx="1363557" cy="307777"/>
              <a:chOff x="889772" y="4068821"/>
              <a:chExt cx="1059743" cy="224823"/>
            </a:xfrm>
          </p:grpSpPr>
          <p:cxnSp>
            <p:nvCxnSpPr>
              <p:cNvPr id="105" name="Straight Connector 119"/>
              <p:cNvCxnSpPr/>
              <p:nvPr/>
            </p:nvCxnSpPr>
            <p:spPr>
              <a:xfrm>
                <a:off x="889772" y="4222709"/>
                <a:ext cx="180000" cy="0"/>
              </a:xfrm>
              <a:prstGeom prst="line">
                <a:avLst/>
              </a:prstGeom>
              <a:ln w="571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Box 122"/>
              <p:cNvSpPr txBox="1"/>
              <p:nvPr/>
            </p:nvSpPr>
            <p:spPr>
              <a:xfrm>
                <a:off x="1109570" y="4068821"/>
                <a:ext cx="839945" cy="224823"/>
              </a:xfrm>
              <a:prstGeom prst="rect">
                <a:avLst/>
              </a:prstGeom>
              <a:noFill/>
              <a:ln w="571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IR-1 KO</a:t>
                </a:r>
              </a:p>
            </p:txBody>
          </p:sp>
        </p:grpSp>
        <p:grpSp>
          <p:nvGrpSpPr>
            <p:cNvPr id="102" name="Group 13"/>
            <p:cNvGrpSpPr/>
            <p:nvPr/>
          </p:nvGrpSpPr>
          <p:grpSpPr>
            <a:xfrm>
              <a:off x="9401340" y="2916894"/>
              <a:ext cx="880522" cy="307777"/>
              <a:chOff x="889772" y="4269593"/>
              <a:chExt cx="684334" cy="224823"/>
            </a:xfrm>
          </p:grpSpPr>
          <p:cxnSp>
            <p:nvCxnSpPr>
              <p:cNvPr id="103" name="Straight Connector 120"/>
              <p:cNvCxnSpPr/>
              <p:nvPr/>
            </p:nvCxnSpPr>
            <p:spPr>
              <a:xfrm>
                <a:off x="889772" y="4423481"/>
                <a:ext cx="180000" cy="0"/>
              </a:xfrm>
              <a:prstGeom prst="line">
                <a:avLst/>
              </a:prstGeom>
              <a:ln w="571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TextBox 139"/>
              <p:cNvSpPr txBox="1"/>
              <p:nvPr/>
            </p:nvSpPr>
            <p:spPr>
              <a:xfrm>
                <a:off x="1120371" y="4269593"/>
                <a:ext cx="453735" cy="224823"/>
              </a:xfrm>
              <a:prstGeom prst="rect">
                <a:avLst/>
              </a:prstGeom>
              <a:noFill/>
              <a:ln w="571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GB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KO</a:t>
                </a:r>
              </a:p>
            </p:txBody>
          </p:sp>
        </p:grpSp>
      </p:grpSp>
      <p:pic>
        <p:nvPicPr>
          <p:cNvPr id="111" name="Image 11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0018" y="12455072"/>
            <a:ext cx="2488248" cy="2736532"/>
          </a:xfrm>
          <a:prstGeom prst="rect">
            <a:avLst/>
          </a:prstGeom>
        </p:spPr>
      </p:pic>
      <p:sp>
        <p:nvSpPr>
          <p:cNvPr id="112" name="TextBox 40"/>
          <p:cNvSpPr txBox="1"/>
          <p:nvPr/>
        </p:nvSpPr>
        <p:spPr>
          <a:xfrm>
            <a:off x="2090046" y="9520752"/>
            <a:ext cx="9845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RP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1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µg/mL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40"/>
          <p:cNvSpPr txBox="1"/>
          <p:nvPr/>
        </p:nvSpPr>
        <p:spPr>
          <a:xfrm>
            <a:off x="8185648" y="9520752"/>
            <a:ext cx="9845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RP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3 µg/mL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40"/>
          <p:cNvSpPr txBox="1"/>
          <p:nvPr/>
        </p:nvSpPr>
        <p:spPr>
          <a:xfrm>
            <a:off x="5451691" y="6515580"/>
            <a:ext cx="1133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RP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0.3 µg/mL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5" name="Image 11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563096" y="12492016"/>
            <a:ext cx="2391093" cy="2736532"/>
          </a:xfrm>
          <a:prstGeom prst="rect">
            <a:avLst/>
          </a:prstGeom>
        </p:spPr>
      </p:pic>
      <p:grpSp>
        <p:nvGrpSpPr>
          <p:cNvPr id="11" name="Groupe 10"/>
          <p:cNvGrpSpPr/>
          <p:nvPr/>
        </p:nvGrpSpPr>
        <p:grpSpPr>
          <a:xfrm>
            <a:off x="341164" y="10309555"/>
            <a:ext cx="2196100" cy="1817749"/>
            <a:chOff x="341164" y="10309555"/>
            <a:chExt cx="2196100" cy="1817749"/>
          </a:xfrm>
        </p:grpSpPr>
        <p:pic>
          <p:nvPicPr>
            <p:cNvPr id="128" name="Image 127"/>
            <p:cNvPicPr>
              <a:picLocks noChangeAspect="1"/>
            </p:cNvPicPr>
            <p:nvPr/>
          </p:nvPicPr>
          <p:blipFill rotWithShape="1">
            <a:blip r:embed="rId14"/>
            <a:srcRect l="15867" t="32141" r="12429" b="16757"/>
            <a:stretch/>
          </p:blipFill>
          <p:spPr>
            <a:xfrm flipV="1">
              <a:off x="904121" y="10519716"/>
              <a:ext cx="1633143" cy="1270214"/>
            </a:xfrm>
            <a:prstGeom prst="rect">
              <a:avLst/>
            </a:prstGeom>
          </p:spPr>
        </p:pic>
        <p:grpSp>
          <p:nvGrpSpPr>
            <p:cNvPr id="129" name="Groupe 128"/>
            <p:cNvGrpSpPr>
              <a:grpSpLocks noChangeAspect="1"/>
            </p:cNvGrpSpPr>
            <p:nvPr/>
          </p:nvGrpSpPr>
          <p:grpSpPr>
            <a:xfrm flipV="1">
              <a:off x="341164" y="10309555"/>
              <a:ext cx="482590" cy="1356301"/>
              <a:chOff x="459445" y="2402632"/>
              <a:chExt cx="682196" cy="1616671"/>
            </a:xfrm>
          </p:grpSpPr>
          <p:sp>
            <p:nvSpPr>
              <p:cNvPr id="130" name="Rectangle 252"/>
              <p:cNvSpPr>
                <a:spLocks noChangeArrowheads="1"/>
              </p:cNvSpPr>
              <p:nvPr/>
            </p:nvSpPr>
            <p:spPr bwMode="auto">
              <a:xfrm rot="16200000">
                <a:off x="138" y="3074993"/>
                <a:ext cx="1157905" cy="2392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% </a:t>
                </a:r>
                <a:r>
                  <a:rPr kumimoji="0" lang="fr-FR" altLang="fr-FR" sz="1100" b="1" i="0" u="none" strike="noStrike" cap="none" normalizeH="0" baseline="0" dirty="0" err="1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aggregation</a:t>
                </a:r>
                <a:endParaRPr kumimoji="0" lang="fr-FR" altLang="fr-F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131" name="Groupe 130"/>
              <p:cNvGrpSpPr/>
              <p:nvPr/>
            </p:nvGrpSpPr>
            <p:grpSpPr>
              <a:xfrm>
                <a:off x="675745" y="2402632"/>
                <a:ext cx="465896" cy="1616671"/>
                <a:chOff x="675745" y="2402632"/>
                <a:chExt cx="465896" cy="1616671"/>
              </a:xfrm>
            </p:grpSpPr>
            <p:sp>
              <p:nvSpPr>
                <p:cNvPr id="132" name="Parenthèse fermante 131"/>
                <p:cNvSpPr/>
                <p:nvPr/>
              </p:nvSpPr>
              <p:spPr>
                <a:xfrm>
                  <a:off x="1064214" y="2474640"/>
                  <a:ext cx="77427" cy="1440000"/>
                </a:xfrm>
                <a:prstGeom prst="rightBracket">
                  <a:avLst>
                    <a:gd name="adj" fmla="val 0"/>
                  </a:avLst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100"/>
                </a:p>
              </p:txBody>
            </p:sp>
            <p:sp>
              <p:nvSpPr>
                <p:cNvPr id="133" name="Rectangle 256"/>
                <p:cNvSpPr>
                  <a:spLocks noChangeArrowheads="1"/>
                </p:cNvSpPr>
                <p:nvPr/>
              </p:nvSpPr>
              <p:spPr bwMode="auto">
                <a:xfrm>
                  <a:off x="897815" y="2402632"/>
                  <a:ext cx="111037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4" name="Rectangle 257"/>
                <p:cNvSpPr>
                  <a:spLocks noChangeArrowheads="1"/>
                </p:cNvSpPr>
                <p:nvPr/>
              </p:nvSpPr>
              <p:spPr bwMode="auto">
                <a:xfrm flipV="1">
                  <a:off x="786783" y="3113641"/>
                  <a:ext cx="222070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5" name="Rectangle 258"/>
                <p:cNvSpPr>
                  <a:spLocks noChangeArrowheads="1"/>
                </p:cNvSpPr>
                <p:nvPr/>
              </p:nvSpPr>
              <p:spPr bwMode="auto">
                <a:xfrm flipV="1">
                  <a:off x="675745" y="3817530"/>
                  <a:ext cx="333107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cxnSp>
              <p:nvCxnSpPr>
                <p:cNvPr id="136" name="Connecteur droit 135"/>
                <p:cNvCxnSpPr/>
                <p:nvPr/>
              </p:nvCxnSpPr>
              <p:spPr>
                <a:xfrm>
                  <a:off x="1061252" y="3198575"/>
                  <a:ext cx="72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8" name="Groupe 137"/>
            <p:cNvGrpSpPr/>
            <p:nvPr/>
          </p:nvGrpSpPr>
          <p:grpSpPr>
            <a:xfrm>
              <a:off x="900510" y="11844172"/>
              <a:ext cx="367088" cy="283132"/>
              <a:chOff x="910180" y="7443192"/>
              <a:chExt cx="367088" cy="283132"/>
            </a:xfrm>
          </p:grpSpPr>
          <p:sp>
            <p:nvSpPr>
              <p:cNvPr id="139" name="Parenthèse fermante 138"/>
              <p:cNvSpPr/>
              <p:nvPr/>
            </p:nvSpPr>
            <p:spPr>
              <a:xfrm rot="5400000">
                <a:off x="1067132" y="7346061"/>
                <a:ext cx="60404" cy="254666"/>
              </a:xfrm>
              <a:prstGeom prst="rightBracket">
                <a:avLst>
                  <a:gd name="adj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 sz="1100"/>
              </a:p>
            </p:txBody>
          </p:sp>
          <p:sp>
            <p:nvSpPr>
              <p:cNvPr id="140" name="Rectangle 252"/>
              <p:cNvSpPr>
                <a:spLocks noChangeArrowheads="1"/>
              </p:cNvSpPr>
              <p:nvPr/>
            </p:nvSpPr>
            <p:spPr bwMode="auto">
              <a:xfrm>
                <a:off x="910180" y="7557047"/>
                <a:ext cx="36708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1 min</a:t>
                </a:r>
              </a:p>
            </p:txBody>
          </p:sp>
        </p:grpSp>
      </p:grpSp>
      <p:grpSp>
        <p:nvGrpSpPr>
          <p:cNvPr id="10" name="Groupe 9"/>
          <p:cNvGrpSpPr/>
          <p:nvPr/>
        </p:nvGrpSpPr>
        <p:grpSpPr>
          <a:xfrm>
            <a:off x="6482028" y="10464501"/>
            <a:ext cx="2328145" cy="1817749"/>
            <a:chOff x="6482028" y="10464501"/>
            <a:chExt cx="2328145" cy="1817749"/>
          </a:xfrm>
        </p:grpSpPr>
        <p:pic>
          <p:nvPicPr>
            <p:cNvPr id="137" name="Image 136"/>
            <p:cNvPicPr>
              <a:picLocks noChangeAspect="1"/>
            </p:cNvPicPr>
            <p:nvPr/>
          </p:nvPicPr>
          <p:blipFill rotWithShape="1">
            <a:blip r:embed="rId15"/>
            <a:srcRect l="14659" t="33415" r="8326" b="15592"/>
            <a:stretch/>
          </p:blipFill>
          <p:spPr>
            <a:xfrm flipV="1">
              <a:off x="7035183" y="10630834"/>
              <a:ext cx="1774990" cy="1285346"/>
            </a:xfrm>
            <a:prstGeom prst="rect">
              <a:avLst/>
            </a:prstGeom>
          </p:spPr>
        </p:pic>
        <p:grpSp>
          <p:nvGrpSpPr>
            <p:cNvPr id="9" name="Groupe 8"/>
            <p:cNvGrpSpPr/>
            <p:nvPr/>
          </p:nvGrpSpPr>
          <p:grpSpPr>
            <a:xfrm>
              <a:off x="6482028" y="10464501"/>
              <a:ext cx="926434" cy="1817749"/>
              <a:chOff x="6482028" y="10464501"/>
              <a:chExt cx="926434" cy="1817749"/>
            </a:xfrm>
          </p:grpSpPr>
          <p:grpSp>
            <p:nvGrpSpPr>
              <p:cNvPr id="141" name="Groupe 140"/>
              <p:cNvGrpSpPr>
                <a:grpSpLocks noChangeAspect="1"/>
              </p:cNvGrpSpPr>
              <p:nvPr/>
            </p:nvGrpSpPr>
            <p:grpSpPr>
              <a:xfrm flipV="1">
                <a:off x="6482028" y="10464501"/>
                <a:ext cx="482590" cy="1356301"/>
                <a:chOff x="459445" y="2402632"/>
                <a:chExt cx="682196" cy="1616671"/>
              </a:xfrm>
            </p:grpSpPr>
            <p:sp>
              <p:nvSpPr>
                <p:cNvPr id="142" name="Rectangle 252"/>
                <p:cNvSpPr>
                  <a:spLocks noChangeArrowheads="1"/>
                </p:cNvSpPr>
                <p:nvPr/>
              </p:nvSpPr>
              <p:spPr bwMode="auto">
                <a:xfrm rot="16200000">
                  <a:off x="138" y="3074993"/>
                  <a:ext cx="1157905" cy="23929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rPr>
                    <a:t>% </a:t>
                  </a:r>
                  <a:r>
                    <a:rPr kumimoji="0" lang="fr-FR" altLang="fr-FR" sz="1100" b="1" i="0" u="none" strike="noStrike" cap="none" normalizeH="0" baseline="0" dirty="0" err="1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rPr>
                    <a:t>aggregation</a:t>
                  </a:r>
                  <a:endPara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grpSp>
              <p:nvGrpSpPr>
                <p:cNvPr id="143" name="Groupe 142"/>
                <p:cNvGrpSpPr/>
                <p:nvPr/>
              </p:nvGrpSpPr>
              <p:grpSpPr>
                <a:xfrm>
                  <a:off x="675745" y="2402632"/>
                  <a:ext cx="465896" cy="1616671"/>
                  <a:chOff x="675745" y="2402632"/>
                  <a:chExt cx="465896" cy="1616671"/>
                </a:xfrm>
              </p:grpSpPr>
              <p:sp>
                <p:nvSpPr>
                  <p:cNvPr id="144" name="Parenthèse fermante 143"/>
                  <p:cNvSpPr/>
                  <p:nvPr/>
                </p:nvSpPr>
                <p:spPr>
                  <a:xfrm>
                    <a:off x="1064214" y="2474640"/>
                    <a:ext cx="77427" cy="1440000"/>
                  </a:xfrm>
                  <a:prstGeom prst="rightBracket">
                    <a:avLst>
                      <a:gd name="adj" fmla="val 0"/>
                    </a:avLst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sz="1100"/>
                  </a:p>
                </p:txBody>
              </p:sp>
              <p:sp>
                <p:nvSpPr>
                  <p:cNvPr id="145" name="Rectangle 256"/>
                  <p:cNvSpPr>
                    <a:spLocks noChangeArrowheads="1"/>
                  </p:cNvSpPr>
                  <p:nvPr/>
                </p:nvSpPr>
                <p:spPr bwMode="auto">
                  <a:xfrm>
                    <a:off x="897815" y="2402632"/>
                    <a:ext cx="111037" cy="20177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371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18288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2860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743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200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657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</a:t>
                    </a:r>
                    <a:endParaRPr kumimoji="0" lang="fr-FR" altLang="fr-FR" sz="11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Rectangle 257"/>
                  <p:cNvSpPr>
                    <a:spLocks noChangeArrowheads="1"/>
                  </p:cNvSpPr>
                  <p:nvPr/>
                </p:nvSpPr>
                <p:spPr bwMode="auto">
                  <a:xfrm flipV="1">
                    <a:off x="786783" y="3113641"/>
                    <a:ext cx="222070" cy="20177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371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18288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2860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743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200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657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50</a:t>
                    </a:r>
                    <a:endParaRPr kumimoji="0" lang="fr-FR" altLang="fr-FR" sz="11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Rectangle 258"/>
                  <p:cNvSpPr>
                    <a:spLocks noChangeArrowheads="1"/>
                  </p:cNvSpPr>
                  <p:nvPr/>
                </p:nvSpPr>
                <p:spPr bwMode="auto">
                  <a:xfrm flipV="1">
                    <a:off x="675745" y="3817530"/>
                    <a:ext cx="333107" cy="20177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914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371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18288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2860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743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2004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657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00</a:t>
                    </a:r>
                    <a:endParaRPr kumimoji="0" lang="fr-FR" altLang="fr-FR" sz="11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cxnSp>
                <p:nvCxnSpPr>
                  <p:cNvPr id="148" name="Connecteur droit 147"/>
                  <p:cNvCxnSpPr/>
                  <p:nvPr/>
                </p:nvCxnSpPr>
                <p:spPr>
                  <a:xfrm>
                    <a:off x="1061252" y="3198575"/>
                    <a:ext cx="72000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49" name="Groupe 148"/>
              <p:cNvGrpSpPr/>
              <p:nvPr/>
            </p:nvGrpSpPr>
            <p:grpSpPr>
              <a:xfrm>
                <a:off x="7041374" y="11999118"/>
                <a:ext cx="367088" cy="283132"/>
                <a:chOff x="910180" y="7443192"/>
                <a:chExt cx="367088" cy="283132"/>
              </a:xfrm>
            </p:grpSpPr>
            <p:sp>
              <p:nvSpPr>
                <p:cNvPr id="150" name="Parenthèse fermante 149"/>
                <p:cNvSpPr/>
                <p:nvPr/>
              </p:nvSpPr>
              <p:spPr>
                <a:xfrm rot="5400000">
                  <a:off x="1067132" y="7346061"/>
                  <a:ext cx="60404" cy="254666"/>
                </a:xfrm>
                <a:prstGeom prst="rightBracket">
                  <a:avLst>
                    <a:gd name="adj" fmla="val 0"/>
                  </a:avLst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100"/>
                </a:p>
              </p:txBody>
            </p:sp>
            <p:sp>
              <p:nvSpPr>
                <p:cNvPr id="151" name="Rectangle 252"/>
                <p:cNvSpPr>
                  <a:spLocks noChangeArrowheads="1"/>
                </p:cNvSpPr>
                <p:nvPr/>
              </p:nvSpPr>
              <p:spPr bwMode="auto">
                <a:xfrm>
                  <a:off x="910180" y="7557047"/>
                  <a:ext cx="367088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rPr>
                    <a:t>1 min</a:t>
                  </a:r>
                </a:p>
              </p:txBody>
            </p:sp>
          </p:grpSp>
        </p:grpSp>
      </p:grpSp>
      <p:grpSp>
        <p:nvGrpSpPr>
          <p:cNvPr id="13" name="Groupe 12"/>
          <p:cNvGrpSpPr/>
          <p:nvPr/>
        </p:nvGrpSpPr>
        <p:grpSpPr>
          <a:xfrm>
            <a:off x="3683103" y="7299176"/>
            <a:ext cx="2156315" cy="1791708"/>
            <a:chOff x="3683103" y="7299176"/>
            <a:chExt cx="2156315" cy="1791708"/>
          </a:xfrm>
        </p:grpSpPr>
        <p:grpSp>
          <p:nvGrpSpPr>
            <p:cNvPr id="152" name="Groupe 151"/>
            <p:cNvGrpSpPr>
              <a:grpSpLocks noChangeAspect="1"/>
            </p:cNvGrpSpPr>
            <p:nvPr/>
          </p:nvGrpSpPr>
          <p:grpSpPr>
            <a:xfrm flipV="1">
              <a:off x="3683103" y="7299176"/>
              <a:ext cx="482590" cy="1356301"/>
              <a:chOff x="459445" y="2402632"/>
              <a:chExt cx="682196" cy="1616671"/>
            </a:xfrm>
          </p:grpSpPr>
          <p:sp>
            <p:nvSpPr>
              <p:cNvPr id="153" name="Rectangle 252"/>
              <p:cNvSpPr>
                <a:spLocks noChangeArrowheads="1"/>
              </p:cNvSpPr>
              <p:nvPr/>
            </p:nvSpPr>
            <p:spPr bwMode="auto">
              <a:xfrm rot="16200000">
                <a:off x="138" y="3074993"/>
                <a:ext cx="1157905" cy="2392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% </a:t>
                </a:r>
                <a:r>
                  <a:rPr kumimoji="0" lang="fr-FR" altLang="fr-FR" sz="1100" b="1" i="0" u="none" strike="noStrike" cap="none" normalizeH="0" baseline="0" dirty="0" err="1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aggregation</a:t>
                </a:r>
                <a:endParaRPr kumimoji="0" lang="fr-FR" altLang="fr-FR" sz="11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154" name="Groupe 153"/>
              <p:cNvGrpSpPr/>
              <p:nvPr/>
            </p:nvGrpSpPr>
            <p:grpSpPr>
              <a:xfrm>
                <a:off x="675745" y="2402632"/>
                <a:ext cx="465896" cy="1616671"/>
                <a:chOff x="675745" y="2402632"/>
                <a:chExt cx="465896" cy="1616671"/>
              </a:xfrm>
            </p:grpSpPr>
            <p:sp>
              <p:nvSpPr>
                <p:cNvPr id="155" name="Parenthèse fermante 154"/>
                <p:cNvSpPr/>
                <p:nvPr/>
              </p:nvSpPr>
              <p:spPr>
                <a:xfrm>
                  <a:off x="1064214" y="2474640"/>
                  <a:ext cx="77427" cy="1440000"/>
                </a:xfrm>
                <a:prstGeom prst="rightBracket">
                  <a:avLst>
                    <a:gd name="adj" fmla="val 0"/>
                  </a:avLst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 sz="1100"/>
                </a:p>
              </p:txBody>
            </p:sp>
            <p:sp>
              <p:nvSpPr>
                <p:cNvPr id="156" name="Rectangle 256"/>
                <p:cNvSpPr>
                  <a:spLocks noChangeArrowheads="1"/>
                </p:cNvSpPr>
                <p:nvPr/>
              </p:nvSpPr>
              <p:spPr bwMode="auto">
                <a:xfrm>
                  <a:off x="897815" y="2402632"/>
                  <a:ext cx="111037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7" name="Rectangle 257"/>
                <p:cNvSpPr>
                  <a:spLocks noChangeArrowheads="1"/>
                </p:cNvSpPr>
                <p:nvPr/>
              </p:nvSpPr>
              <p:spPr bwMode="auto">
                <a:xfrm flipV="1">
                  <a:off x="786783" y="3113641"/>
                  <a:ext cx="222070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8" name="Rectangle 258"/>
                <p:cNvSpPr>
                  <a:spLocks noChangeArrowheads="1"/>
                </p:cNvSpPr>
                <p:nvPr/>
              </p:nvSpPr>
              <p:spPr bwMode="auto">
                <a:xfrm flipV="1">
                  <a:off x="675745" y="3817530"/>
                  <a:ext cx="333107" cy="20177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fr-FR" altLang="fr-F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cxnSp>
              <p:nvCxnSpPr>
                <p:cNvPr id="159" name="Connecteur droit 158"/>
                <p:cNvCxnSpPr/>
                <p:nvPr/>
              </p:nvCxnSpPr>
              <p:spPr>
                <a:xfrm>
                  <a:off x="1061252" y="3198575"/>
                  <a:ext cx="72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16" name="Image 115"/>
            <p:cNvPicPr>
              <a:picLocks noChangeAspect="1"/>
            </p:cNvPicPr>
            <p:nvPr/>
          </p:nvPicPr>
          <p:blipFill rotWithShape="1">
            <a:blip r:embed="rId16"/>
            <a:srcRect l="13334" t="34177" r="13639" b="17928"/>
            <a:stretch/>
          </p:blipFill>
          <p:spPr>
            <a:xfrm flipV="1">
              <a:off x="4190157" y="7547847"/>
              <a:ext cx="1649261" cy="1182997"/>
            </a:xfrm>
            <a:prstGeom prst="rect">
              <a:avLst/>
            </a:prstGeom>
          </p:spPr>
        </p:pic>
        <p:grpSp>
          <p:nvGrpSpPr>
            <p:cNvPr id="12" name="Groupe 11"/>
            <p:cNvGrpSpPr/>
            <p:nvPr/>
          </p:nvGrpSpPr>
          <p:grpSpPr>
            <a:xfrm>
              <a:off x="4241783" y="8807752"/>
              <a:ext cx="367088" cy="283132"/>
              <a:chOff x="4241783" y="9032268"/>
              <a:chExt cx="367088" cy="283132"/>
            </a:xfrm>
          </p:grpSpPr>
          <p:sp>
            <p:nvSpPr>
              <p:cNvPr id="160" name="Parenthèse fermante 159"/>
              <p:cNvSpPr/>
              <p:nvPr/>
            </p:nvSpPr>
            <p:spPr>
              <a:xfrm rot="5400000">
                <a:off x="4398735" y="8935137"/>
                <a:ext cx="60404" cy="254666"/>
              </a:xfrm>
              <a:prstGeom prst="rightBracket">
                <a:avLst>
                  <a:gd name="adj" fmla="val 0"/>
                </a:avLst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 sz="1100"/>
              </a:p>
            </p:txBody>
          </p:sp>
          <p:sp>
            <p:nvSpPr>
              <p:cNvPr id="161" name="Rectangle 252"/>
              <p:cNvSpPr>
                <a:spLocks noChangeArrowheads="1"/>
              </p:cNvSpPr>
              <p:nvPr/>
            </p:nvSpPr>
            <p:spPr bwMode="auto">
              <a:xfrm>
                <a:off x="4241783" y="9146123"/>
                <a:ext cx="36708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1 min</a:t>
                </a:r>
              </a:p>
            </p:txBody>
          </p:sp>
        </p:grpSp>
      </p:grpSp>
      <p:graphicFrame>
        <p:nvGraphicFramePr>
          <p:cNvPr id="68" name="Objet 6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9607993"/>
              </p:ext>
            </p:extLst>
          </p:nvPr>
        </p:nvGraphicFramePr>
        <p:xfrm>
          <a:off x="2861444" y="12502539"/>
          <a:ext cx="2079387" cy="2933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3" name="Prism 9" r:id="rId17" imgW="2447122" imgH="3450692" progId="Prism9.Document">
                  <p:embed/>
                </p:oleObj>
              </mc:Choice>
              <mc:Fallback>
                <p:oleObj name="Prism 9" r:id="rId17" imgW="2447122" imgH="3450692" progId="Prism9.Document">
                  <p:embed/>
                  <p:pic>
                    <p:nvPicPr>
                      <p:cNvPr id="47" name="Objet 46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861444" y="12502539"/>
                        <a:ext cx="2079387" cy="2933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26986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317834" y="3204596"/>
            <a:ext cx="4864594" cy="3488536"/>
            <a:chOff x="3317834" y="5426968"/>
            <a:chExt cx="4864594" cy="3488536"/>
          </a:xfrm>
        </p:grpSpPr>
        <p:pic>
          <p:nvPicPr>
            <p:cNvPr id="3" name="Image 2"/>
            <p:cNvPicPr preferRelativeResize="0">
              <a:picLocks/>
            </p:cNvPicPr>
            <p:nvPr/>
          </p:nvPicPr>
          <p:blipFill rotWithShape="1">
            <a:blip r:embed="rId2"/>
            <a:srcRect l="35165" t="51442" r="27972" b="41322"/>
            <a:stretch/>
          </p:blipFill>
          <p:spPr>
            <a:xfrm>
              <a:off x="3317834" y="7276337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4" name="ZoneTexte 3"/>
            <p:cNvSpPr txBox="1"/>
            <p:nvPr/>
          </p:nvSpPr>
          <p:spPr>
            <a:xfrm>
              <a:off x="3688768" y="5426968"/>
              <a:ext cx="4172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K</a:t>
              </a:r>
            </a:p>
          </p:txBody>
        </p:sp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48760" t="45252" r="-552" b="48280"/>
            <a:stretch/>
          </p:blipFill>
          <p:spPr>
            <a:xfrm>
              <a:off x="3317834" y="7847480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6" name="TextBox 9"/>
            <p:cNvSpPr txBox="1"/>
            <p:nvPr/>
          </p:nvSpPr>
          <p:spPr>
            <a:xfrm>
              <a:off x="4439748" y="7380838"/>
              <a:ext cx="5600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p1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21"/>
            <p:cNvSpPr txBox="1"/>
            <p:nvPr/>
          </p:nvSpPr>
          <p:spPr>
            <a:xfrm>
              <a:off x="4439748" y="7951981"/>
              <a:ext cx="5600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p2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21"/>
            <p:cNvSpPr txBox="1"/>
            <p:nvPr/>
          </p:nvSpPr>
          <p:spPr>
            <a:xfrm>
              <a:off x="4439748" y="8534004"/>
              <a:ext cx="7504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Image 8"/>
            <p:cNvPicPr preferRelativeResize="0">
              <a:picLocks/>
            </p:cNvPicPr>
            <p:nvPr/>
          </p:nvPicPr>
          <p:blipFill rotWithShape="1">
            <a:blip r:embed="rId5"/>
            <a:srcRect l="2964" t="55442" r="3234" b="3428"/>
            <a:stretch/>
          </p:blipFill>
          <p:spPr>
            <a:xfrm>
              <a:off x="3317834" y="6697167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10" name="TextBox 9"/>
            <p:cNvSpPr txBox="1"/>
            <p:nvPr/>
          </p:nvSpPr>
          <p:spPr>
            <a:xfrm>
              <a:off x="4439748" y="6218970"/>
              <a:ext cx="461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sk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21"/>
            <p:cNvSpPr txBox="1"/>
            <p:nvPr/>
          </p:nvSpPr>
          <p:spPr>
            <a:xfrm>
              <a:off x="4439748" y="6801668"/>
              <a:ext cx="470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k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9"/>
            <p:cNvSpPr txBox="1"/>
            <p:nvPr/>
          </p:nvSpPr>
          <p:spPr>
            <a:xfrm>
              <a:off x="7431933" y="7380838"/>
              <a:ext cx="5600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p1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21"/>
            <p:cNvSpPr txBox="1"/>
            <p:nvPr/>
          </p:nvSpPr>
          <p:spPr>
            <a:xfrm>
              <a:off x="7431933" y="7951981"/>
              <a:ext cx="5600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p2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21"/>
            <p:cNvSpPr txBox="1"/>
            <p:nvPr/>
          </p:nvSpPr>
          <p:spPr>
            <a:xfrm>
              <a:off x="7431933" y="8534004"/>
              <a:ext cx="7504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9"/>
            <p:cNvSpPr txBox="1"/>
            <p:nvPr/>
          </p:nvSpPr>
          <p:spPr>
            <a:xfrm>
              <a:off x="7431933" y="6218970"/>
              <a:ext cx="461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sk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21"/>
            <p:cNvSpPr txBox="1"/>
            <p:nvPr/>
          </p:nvSpPr>
          <p:spPr>
            <a:xfrm>
              <a:off x="7431933" y="6801668"/>
              <a:ext cx="470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k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Picture 5"/>
            <p:cNvPicPr>
              <a:picLocks/>
            </p:cNvPicPr>
            <p:nvPr/>
          </p:nvPicPr>
          <p:blipFill rotWithShape="1">
            <a:blip r:embed="rId6">
              <a:lum/>
              <a:alphaModFix/>
            </a:blip>
            <a:srcRect l="19912" t="46766" r="67209" b="47424"/>
            <a:stretch/>
          </p:blipFill>
          <p:spPr>
            <a:xfrm>
              <a:off x="6316749" y="6697167"/>
              <a:ext cx="1134000" cy="48600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</p:pic>
        <p:pic>
          <p:nvPicPr>
            <p:cNvPr id="18" name="Picture 5"/>
            <p:cNvPicPr preferRelativeResize="0">
              <a:picLocks/>
            </p:cNvPicPr>
            <p:nvPr/>
          </p:nvPicPr>
          <p:blipFill rotWithShape="1">
            <a:blip r:embed="rId6">
              <a:lum/>
              <a:alphaModFix/>
            </a:blip>
            <a:srcRect l="7449" t="47424" r="79584" b="47424"/>
            <a:stretch/>
          </p:blipFill>
          <p:spPr>
            <a:xfrm>
              <a:off x="6316749" y="6114470"/>
              <a:ext cx="1134000" cy="48600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</p:pic>
        <p:pic>
          <p:nvPicPr>
            <p:cNvPr id="19" name="Image 18"/>
            <p:cNvPicPr preferRelativeResize="0">
              <a:picLocks/>
            </p:cNvPicPr>
            <p:nvPr/>
          </p:nvPicPr>
          <p:blipFill rotWithShape="1">
            <a:blip r:embed="rId7"/>
            <a:srcRect l="49632" t="48253" r="1162" b="45520"/>
            <a:stretch/>
          </p:blipFill>
          <p:spPr>
            <a:xfrm>
              <a:off x="6316749" y="7276337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0" name="Image 19"/>
            <p:cNvPicPr preferRelativeResize="0">
              <a:picLocks/>
            </p:cNvPicPr>
            <p:nvPr/>
          </p:nvPicPr>
          <p:blipFill rotWithShape="1">
            <a:blip r:embed="rId8"/>
            <a:srcRect l="50682" t="47774" r="1201" b="46162"/>
            <a:stretch/>
          </p:blipFill>
          <p:spPr>
            <a:xfrm>
              <a:off x="6316749" y="7847480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1" name="Image 20"/>
            <p:cNvPicPr preferRelativeResize="0">
              <a:picLocks/>
            </p:cNvPicPr>
            <p:nvPr/>
          </p:nvPicPr>
          <p:blipFill rotWithShape="1">
            <a:blip r:embed="rId9"/>
            <a:srcRect l="50136" t="57011" b="37197"/>
            <a:stretch/>
          </p:blipFill>
          <p:spPr>
            <a:xfrm>
              <a:off x="6316749" y="8429504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2" name="Image 21"/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317834" y="6114470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pic>
          <p:nvPicPr>
            <p:cNvPr id="23" name="Image 22"/>
            <p:cNvPicPr preferRelativeResize="0">
              <a:picLocks/>
            </p:cNvPicPr>
            <p:nvPr/>
          </p:nvPicPr>
          <p:blipFill rotWithShape="1">
            <a:blip r:embed="rId11"/>
            <a:srcRect t="57621" r="50723" b="37679"/>
            <a:stretch/>
          </p:blipFill>
          <p:spPr>
            <a:xfrm>
              <a:off x="3317834" y="8429504"/>
              <a:ext cx="1134000" cy="486000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24" name="ZoneTexte 23"/>
            <p:cNvSpPr txBox="1"/>
            <p:nvPr/>
          </p:nvSpPr>
          <p:spPr>
            <a:xfrm>
              <a:off x="3386695" y="5806346"/>
              <a:ext cx="4172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3915683" y="5806346"/>
              <a:ext cx="525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KO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6413424" y="5806346"/>
              <a:ext cx="4172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6880132" y="5806346"/>
              <a:ext cx="525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KO</a:t>
              </a:r>
            </a:p>
          </p:txBody>
        </p:sp>
        <p:cxnSp>
          <p:nvCxnSpPr>
            <p:cNvPr id="28" name="Connecteur droit 27"/>
            <p:cNvCxnSpPr/>
            <p:nvPr/>
          </p:nvCxnSpPr>
          <p:spPr>
            <a:xfrm>
              <a:off x="3330382" y="5751102"/>
              <a:ext cx="113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>
              <a:off x="6469549" y="5437263"/>
              <a:ext cx="828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latelets</a:t>
              </a:r>
              <a:endParaRPr lang="fr-FR" sz="14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Connecteur droit 29"/>
            <p:cNvCxnSpPr/>
            <p:nvPr/>
          </p:nvCxnSpPr>
          <p:spPr>
            <a:xfrm>
              <a:off x="6316749" y="5761397"/>
              <a:ext cx="113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1" name="Image 3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20067" y="7129668"/>
            <a:ext cx="2754630" cy="2194559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502817" y="7192849"/>
            <a:ext cx="2754630" cy="2194559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3681823" y="6941127"/>
            <a:ext cx="4172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K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6570886" y="7014603"/>
            <a:ext cx="8284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elets</a:t>
            </a:r>
            <a:endParaRPr lang="fr-FR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>
            <a:spLocks noChangeArrowheads="1"/>
          </p:cNvSpPr>
          <p:nvPr/>
        </p:nvSpPr>
        <p:spPr bwMode="auto">
          <a:xfrm>
            <a:off x="1439549" y="1826568"/>
            <a:ext cx="88200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GB" altLang="fr-FR" sz="14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3:</a:t>
            </a:r>
            <a:r>
              <a:rPr kumimoji="0" lang="en-GB" altLang="fr-FR" sz="1400" b="1" i="0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</a:t>
            </a:r>
            <a:r>
              <a:rPr kumimoji="0" lang="en-GB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tein expression level of </a:t>
            </a:r>
            <a:r>
              <a:rPr kumimoji="0" lang="en-GB" altLang="fr-FR" sz="14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sk</a:t>
            </a:r>
            <a:r>
              <a:rPr kumimoji="0" lang="en-GB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en-GB" altLang="fr-FR" sz="14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k</a:t>
            </a:r>
            <a:r>
              <a:rPr kumimoji="0" lang="en-GB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Shp1 and Shp2 in WT and </a:t>
            </a:r>
            <a:r>
              <a:rPr lang="en-GB" altLang="fr-FR" sz="14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CAM-1/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AIR-1 </a:t>
            </a:r>
            <a:r>
              <a:rPr kumimoji="0" lang="en-GB" altLang="fr-FR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KO megakaryocytes (MK) and platelets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hol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ell lysates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Ks and platelets wer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alyzed by capillary-based immunoassays with indicated antibodies.  Representativ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lot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d quantification of normalized peak area are show mean ± SEM; n = 3 independent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/genotype.</a:t>
            </a:r>
            <a:endParaRPr kumimoji="0" lang="en-GB" altLang="fr-F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>
            <a:spLocks noChangeArrowheads="1"/>
          </p:cNvSpPr>
          <p:nvPr/>
        </p:nvSpPr>
        <p:spPr bwMode="auto">
          <a:xfrm>
            <a:off x="1439549" y="10205984"/>
            <a:ext cx="88200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1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4:</a:t>
            </a:r>
            <a:r>
              <a:rPr lang="en-GB" altLang="fr-FR" sz="1400" b="1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PECAM-1/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IR-1 DKO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ce do not exhibit a bleeding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athesis following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il injury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rmal blood loss o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ECAM-1/LAIR-1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KO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n =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ice compare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ith litter-match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ild-type (WT) mice (n = 9) in the tail bleeding assay (3 mm cut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  Symbol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present individual mic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orizontal line represents mean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altLang="fr-FR" sz="1400" b="1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Image 3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97382" y="11197604"/>
            <a:ext cx="3752850" cy="2654300"/>
          </a:xfrm>
          <a:prstGeom prst="rect">
            <a:avLst/>
          </a:prstGeom>
        </p:spPr>
      </p:pic>
      <p:sp>
        <p:nvSpPr>
          <p:cNvPr id="38" name="Rectangle 37"/>
          <p:cNvSpPr/>
          <p:nvPr/>
        </p:nvSpPr>
        <p:spPr>
          <a:xfrm>
            <a:off x="83291" y="421607"/>
            <a:ext cx="1587034" cy="369332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ctr"/>
            <a:r>
              <a:rPr lang="en-GB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mith et al</a:t>
            </a:r>
            <a:endParaRPr lang="en-GB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941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3</TotalTime>
  <Words>516</Words>
  <Application>Microsoft Office PowerPoint</Application>
  <PresentationFormat>Personnalisé</PresentationFormat>
  <Paragraphs>134</Paragraphs>
  <Slides>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rism 9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</dc:creator>
  <cp:lastModifiedBy>Senis-Mazharian Alexandra</cp:lastModifiedBy>
  <cp:revision>234</cp:revision>
  <cp:lastPrinted>2017-10-26T10:54:25Z</cp:lastPrinted>
  <dcterms:created xsi:type="dcterms:W3CDTF">2017-10-25T10:06:07Z</dcterms:created>
  <dcterms:modified xsi:type="dcterms:W3CDTF">2024-09-13T11:35:25Z</dcterms:modified>
</cp:coreProperties>
</file>